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  <p:sldId id="259" r:id="rId3"/>
    <p:sldId id="260" r:id="rId4"/>
    <p:sldId id="261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101" d="100"/>
          <a:sy n="101" d="100"/>
        </p:scale>
        <p:origin x="-2024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printerSettings" Target="printerSettings/printerSettings1.bin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5561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02500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29922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0189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01923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14681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66921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76054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22287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32031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5209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06805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12618717"/>
              </p:ext>
            </p:extLst>
          </p:nvPr>
        </p:nvGraphicFramePr>
        <p:xfrm>
          <a:off x="2667000" y="1981200"/>
          <a:ext cx="3149600" cy="3238500"/>
        </p:xfrm>
        <a:graphic>
          <a:graphicData uri="http://schemas.openxmlformats.org/drawingml/2006/table">
            <a:tbl>
              <a:tblPr/>
              <a:tblGrid>
                <a:gridCol w="934700">
                  <a:extLst>
                    <a:ext uri="{9D8B030D-6E8A-4147-A177-3AD203B41FA5}">
                      <a16:colId xmlns:a16="http://schemas.microsoft.com/office/drawing/2014/main" xmlns="" val="3318411738"/>
                    </a:ext>
                  </a:extLst>
                </a:gridCol>
                <a:gridCol w="715678">
                  <a:extLst>
                    <a:ext uri="{9D8B030D-6E8A-4147-A177-3AD203B41FA5}">
                      <a16:colId xmlns:a16="http://schemas.microsoft.com/office/drawing/2014/main" xmlns="" val="3324993616"/>
                    </a:ext>
                  </a:extLst>
                </a:gridCol>
                <a:gridCol w="749611">
                  <a:extLst>
                    <a:ext uri="{9D8B030D-6E8A-4147-A177-3AD203B41FA5}">
                      <a16:colId xmlns:a16="http://schemas.microsoft.com/office/drawing/2014/main" xmlns="" val="2338304562"/>
                    </a:ext>
                  </a:extLst>
                </a:gridCol>
                <a:gridCol w="749611">
                  <a:extLst>
                    <a:ext uri="{9D8B030D-6E8A-4147-A177-3AD203B41FA5}">
                      <a16:colId xmlns:a16="http://schemas.microsoft.com/office/drawing/2014/main" xmlns="" val="120607876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Lun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944.67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255559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9520354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Adrenal glan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94.9872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113179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52757698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Bone marrow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48.6147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149044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74955877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Brai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2.68464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142518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21022099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Colo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9.152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207356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61001818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Fetal Brai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240222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17605253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Fetal Live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60.7656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202253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97745425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Hear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41.087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197046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53288509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Kidney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76.1566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272853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21464488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Splee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64.7489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330230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21094212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Placent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482.240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267393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91347551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Prostat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43.5312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0927235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29280902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Salivary glan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22.9211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297358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7326342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Skeletal muscle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01.228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152380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44100407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Spinal cor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.81520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199168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9372921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Stomach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1.8527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222267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6441058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Thymu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1.3308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250438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69872724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Thyroid glan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97.7751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102651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19865382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Small intestin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22.8246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310857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71184232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Uteru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21.8382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224925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616701303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762000" y="1066800"/>
            <a:ext cx="8050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. 2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692663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066800" y="1219200"/>
            <a:ext cx="792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. 2E</a:t>
            </a:r>
            <a:endParaRPr lang="en-US" dirty="0"/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87720228"/>
              </p:ext>
            </p:extLst>
          </p:nvPr>
        </p:nvGraphicFramePr>
        <p:xfrm>
          <a:off x="2518263" y="1066815"/>
          <a:ext cx="4644539" cy="506189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65472">
                  <a:extLst>
                    <a:ext uri="{9D8B030D-6E8A-4147-A177-3AD203B41FA5}">
                      <a16:colId xmlns:a16="http://schemas.microsoft.com/office/drawing/2014/main" xmlns="" val="3190177124"/>
                    </a:ext>
                  </a:extLst>
                </a:gridCol>
                <a:gridCol w="365472">
                  <a:extLst>
                    <a:ext uri="{9D8B030D-6E8A-4147-A177-3AD203B41FA5}">
                      <a16:colId xmlns:a16="http://schemas.microsoft.com/office/drawing/2014/main" xmlns="" val="3791116376"/>
                    </a:ext>
                  </a:extLst>
                </a:gridCol>
                <a:gridCol w="365472">
                  <a:extLst>
                    <a:ext uri="{9D8B030D-6E8A-4147-A177-3AD203B41FA5}">
                      <a16:colId xmlns:a16="http://schemas.microsoft.com/office/drawing/2014/main" xmlns="" val="3200275778"/>
                    </a:ext>
                  </a:extLst>
                </a:gridCol>
                <a:gridCol w="365472">
                  <a:extLst>
                    <a:ext uri="{9D8B030D-6E8A-4147-A177-3AD203B41FA5}">
                      <a16:colId xmlns:a16="http://schemas.microsoft.com/office/drawing/2014/main" xmlns="" val="4246100300"/>
                    </a:ext>
                  </a:extLst>
                </a:gridCol>
                <a:gridCol w="624347">
                  <a:extLst>
                    <a:ext uri="{9D8B030D-6E8A-4147-A177-3AD203B41FA5}">
                      <a16:colId xmlns:a16="http://schemas.microsoft.com/office/drawing/2014/main" xmlns="" val="1005783854"/>
                    </a:ext>
                  </a:extLst>
                </a:gridCol>
                <a:gridCol w="365472">
                  <a:extLst>
                    <a:ext uri="{9D8B030D-6E8A-4147-A177-3AD203B41FA5}">
                      <a16:colId xmlns:a16="http://schemas.microsoft.com/office/drawing/2014/main" xmlns="" val="2674938549"/>
                    </a:ext>
                  </a:extLst>
                </a:gridCol>
                <a:gridCol w="365472">
                  <a:extLst>
                    <a:ext uri="{9D8B030D-6E8A-4147-A177-3AD203B41FA5}">
                      <a16:colId xmlns:a16="http://schemas.microsoft.com/office/drawing/2014/main" xmlns="" val="2229454341"/>
                    </a:ext>
                  </a:extLst>
                </a:gridCol>
                <a:gridCol w="365472">
                  <a:extLst>
                    <a:ext uri="{9D8B030D-6E8A-4147-A177-3AD203B41FA5}">
                      <a16:colId xmlns:a16="http://schemas.microsoft.com/office/drawing/2014/main" xmlns="" val="3808728214"/>
                    </a:ext>
                  </a:extLst>
                </a:gridCol>
                <a:gridCol w="365472">
                  <a:extLst>
                    <a:ext uri="{9D8B030D-6E8A-4147-A177-3AD203B41FA5}">
                      <a16:colId xmlns:a16="http://schemas.microsoft.com/office/drawing/2014/main" xmlns="" val="2739992369"/>
                    </a:ext>
                  </a:extLst>
                </a:gridCol>
                <a:gridCol w="365472">
                  <a:extLst>
                    <a:ext uri="{9D8B030D-6E8A-4147-A177-3AD203B41FA5}">
                      <a16:colId xmlns:a16="http://schemas.microsoft.com/office/drawing/2014/main" xmlns="" val="1556870529"/>
                    </a:ext>
                  </a:extLst>
                </a:gridCol>
                <a:gridCol w="365472">
                  <a:extLst>
                    <a:ext uri="{9D8B030D-6E8A-4147-A177-3AD203B41FA5}">
                      <a16:colId xmlns:a16="http://schemas.microsoft.com/office/drawing/2014/main" xmlns="" val="1441003488"/>
                    </a:ext>
                  </a:extLst>
                </a:gridCol>
                <a:gridCol w="365472">
                  <a:extLst>
                    <a:ext uri="{9D8B030D-6E8A-4147-A177-3AD203B41FA5}">
                      <a16:colId xmlns:a16="http://schemas.microsoft.com/office/drawing/2014/main" xmlns="" val="550071055"/>
                    </a:ext>
                  </a:extLst>
                </a:gridCol>
              </a:tblGrid>
              <a:tr h="209948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Cycle valu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Cycle valu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600" u="none" strike="noStrike">
                          <a:effectLst/>
                        </a:rPr>
                        <a:t>Δ</a:t>
                      </a:r>
                      <a:r>
                        <a:rPr lang="en-US" sz="600" u="none" strike="noStrike">
                          <a:effectLst/>
                        </a:rPr>
                        <a:t>Ct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Fold chang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P valu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extLst>
                  <a:ext uri="{0D108BD9-81ED-4DB2-BD59-A6C34878D82A}">
                    <a16:rowId xmlns:a16="http://schemas.microsoft.com/office/drawing/2014/main" xmlns="" val="2840654174"/>
                  </a:ext>
                </a:extLst>
              </a:tr>
              <a:tr h="112836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extLst>
                  <a:ext uri="{0D108BD9-81ED-4DB2-BD59-A6C34878D82A}">
                    <a16:rowId xmlns:a16="http://schemas.microsoft.com/office/drawing/2014/main" xmlns="" val="2342607646"/>
                  </a:ext>
                </a:extLst>
              </a:tr>
              <a:tr h="11283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-act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C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4.0865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Pri-miR-12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C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32.5451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8.45858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0284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extLst>
                  <a:ext uri="{0D108BD9-81ED-4DB2-BD59-A6C34878D82A}">
                    <a16:rowId xmlns:a16="http://schemas.microsoft.com/office/drawing/2014/main" xmlns="" val="690651056"/>
                  </a:ext>
                </a:extLst>
              </a:tr>
              <a:tr h="11283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-act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C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1.7263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Pri-miR-12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C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32.5394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10.8130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0055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extLst>
                  <a:ext uri="{0D108BD9-81ED-4DB2-BD59-A6C34878D82A}">
                    <a16:rowId xmlns:a16="http://schemas.microsoft.com/office/drawing/2014/main" xmlns="" val="2974015386"/>
                  </a:ext>
                </a:extLst>
              </a:tr>
              <a:tr h="11283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-act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C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1.8190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Pri-miR-12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C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31.9150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10.0960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0091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extLst>
                  <a:ext uri="{0D108BD9-81ED-4DB2-BD59-A6C34878D82A}">
                    <a16:rowId xmlns:a16="http://schemas.microsoft.com/office/drawing/2014/main" xmlns="" val="2009033770"/>
                  </a:ext>
                </a:extLst>
              </a:tr>
              <a:tr h="11283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-act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C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2.8476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Pri-miR-12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C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32.3287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9.48107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0139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0147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extLst>
                  <a:ext uri="{0D108BD9-81ED-4DB2-BD59-A6C34878D82A}">
                    <a16:rowId xmlns:a16="http://schemas.microsoft.com/office/drawing/2014/main" xmlns="" val="946109913"/>
                  </a:ext>
                </a:extLst>
              </a:tr>
              <a:tr h="11283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-act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C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3.5618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Pri-miR-12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C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32.7822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9.22042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0167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0087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59354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extLst>
                  <a:ext uri="{0D108BD9-81ED-4DB2-BD59-A6C34878D82A}">
                    <a16:rowId xmlns:a16="http://schemas.microsoft.com/office/drawing/2014/main" xmlns="" val="3997264709"/>
                  </a:ext>
                </a:extLst>
              </a:tr>
              <a:tr h="11283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-act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1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4.5445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Pri-miR-12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1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30.2094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5.66486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1971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extLst>
                  <a:ext uri="{0D108BD9-81ED-4DB2-BD59-A6C34878D82A}">
                    <a16:rowId xmlns:a16="http://schemas.microsoft.com/office/drawing/2014/main" xmlns="" val="4190775723"/>
                  </a:ext>
                </a:extLst>
              </a:tr>
              <a:tr h="11283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-act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1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3.9765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Pri-miR-12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1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9.8767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5.90021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1674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extLst>
                  <a:ext uri="{0D108BD9-81ED-4DB2-BD59-A6C34878D82A}">
                    <a16:rowId xmlns:a16="http://schemas.microsoft.com/office/drawing/2014/main" xmlns="" val="4016192913"/>
                  </a:ext>
                </a:extLst>
              </a:tr>
              <a:tr h="11283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-act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2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4.4454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Pri-miR-12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2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8.4722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4.02673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6135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extLst>
                  <a:ext uri="{0D108BD9-81ED-4DB2-BD59-A6C34878D82A}">
                    <a16:rowId xmlns:a16="http://schemas.microsoft.com/office/drawing/2014/main" xmlns="" val="2273349202"/>
                  </a:ext>
                </a:extLst>
              </a:tr>
              <a:tr h="11283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-act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2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3.7358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Pri-miR-12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2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9.3823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5.64654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1996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extLst>
                  <a:ext uri="{0D108BD9-81ED-4DB2-BD59-A6C34878D82A}">
                    <a16:rowId xmlns:a16="http://schemas.microsoft.com/office/drawing/2014/main" xmlns="" val="1218458233"/>
                  </a:ext>
                </a:extLst>
              </a:tr>
              <a:tr h="11283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-act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2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4.3040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Pri-miR-12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2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9.3332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5.02919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3062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extLst>
                  <a:ext uri="{0D108BD9-81ED-4DB2-BD59-A6C34878D82A}">
                    <a16:rowId xmlns:a16="http://schemas.microsoft.com/office/drawing/2014/main" xmlns="" val="1693109285"/>
                  </a:ext>
                </a:extLst>
              </a:tr>
              <a:tr h="11283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-act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2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3.4479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Pri-miR-12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2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9.3432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5.89529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1680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267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18.1041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0585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extLst>
                  <a:ext uri="{0D108BD9-81ED-4DB2-BD59-A6C34878D82A}">
                    <a16:rowId xmlns:a16="http://schemas.microsoft.com/office/drawing/2014/main" xmlns="" val="2529483517"/>
                  </a:ext>
                </a:extLst>
              </a:tr>
              <a:tr h="11283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-act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4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3.582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Pri-miR-12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4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9.0852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5.50280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2205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1596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10.8043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extLst>
                  <a:ext uri="{0D108BD9-81ED-4DB2-BD59-A6C34878D82A}">
                    <a16:rowId xmlns:a16="http://schemas.microsoft.com/office/drawing/2014/main" xmlns="" val="109759937"/>
                  </a:ext>
                </a:extLst>
              </a:tr>
              <a:tr h="112836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extLst>
                  <a:ext uri="{0D108BD9-81ED-4DB2-BD59-A6C34878D82A}">
                    <a16:rowId xmlns:a16="http://schemas.microsoft.com/office/drawing/2014/main" xmlns="" val="1239847083"/>
                  </a:ext>
                </a:extLst>
              </a:tr>
              <a:tr h="112836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extLst>
                  <a:ext uri="{0D108BD9-81ED-4DB2-BD59-A6C34878D82A}">
                    <a16:rowId xmlns:a16="http://schemas.microsoft.com/office/drawing/2014/main" xmlns="" val="2993279528"/>
                  </a:ext>
                </a:extLst>
              </a:tr>
              <a:tr h="112836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extLst>
                  <a:ext uri="{0D108BD9-81ED-4DB2-BD59-A6C34878D82A}">
                    <a16:rowId xmlns:a16="http://schemas.microsoft.com/office/drawing/2014/main" xmlns="" val="2549120685"/>
                  </a:ext>
                </a:extLst>
              </a:tr>
              <a:tr h="11283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-act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C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1.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EGFL7B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C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32.0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10.2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0084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extLst>
                  <a:ext uri="{0D108BD9-81ED-4DB2-BD59-A6C34878D82A}">
                    <a16:rowId xmlns:a16="http://schemas.microsoft.com/office/drawing/2014/main" xmlns="" val="2317999119"/>
                  </a:ext>
                </a:extLst>
              </a:tr>
              <a:tr h="11283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-act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C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0.0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EGFL7B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C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31.6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11.5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0033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extLst>
                  <a:ext uri="{0D108BD9-81ED-4DB2-BD59-A6C34878D82A}">
                    <a16:rowId xmlns:a16="http://schemas.microsoft.com/office/drawing/2014/main" xmlns="" val="3695186868"/>
                  </a:ext>
                </a:extLst>
              </a:tr>
              <a:tr h="11283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-act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C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0.3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EGFL7B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C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31.1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10.7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0056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extLst>
                  <a:ext uri="{0D108BD9-81ED-4DB2-BD59-A6C34878D82A}">
                    <a16:rowId xmlns:a16="http://schemas.microsoft.com/office/drawing/2014/main" xmlns="" val="1693671212"/>
                  </a:ext>
                </a:extLst>
              </a:tr>
              <a:tr h="11283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-act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C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2.0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EGFL7B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C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31.0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8.9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0200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0100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extLst>
                  <a:ext uri="{0D108BD9-81ED-4DB2-BD59-A6C34878D82A}">
                    <a16:rowId xmlns:a16="http://schemas.microsoft.com/office/drawing/2014/main" xmlns="" val="3686431253"/>
                  </a:ext>
                </a:extLst>
              </a:tr>
              <a:tr h="11283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-act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C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1.5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EGFL7B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C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31.1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9.6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012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0066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65695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extLst>
                  <a:ext uri="{0D108BD9-81ED-4DB2-BD59-A6C34878D82A}">
                    <a16:rowId xmlns:a16="http://schemas.microsoft.com/office/drawing/2014/main" xmlns="" val="1654979572"/>
                  </a:ext>
                </a:extLst>
              </a:tr>
              <a:tr h="11283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-act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1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1.9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EGFL7B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1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30.5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8.5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0268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extLst>
                  <a:ext uri="{0D108BD9-81ED-4DB2-BD59-A6C34878D82A}">
                    <a16:rowId xmlns:a16="http://schemas.microsoft.com/office/drawing/2014/main" xmlns="" val="584748050"/>
                  </a:ext>
                </a:extLst>
              </a:tr>
              <a:tr h="11283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-act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1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1.5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EGFL7B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1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31.4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9.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0104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extLst>
                  <a:ext uri="{0D108BD9-81ED-4DB2-BD59-A6C34878D82A}">
                    <a16:rowId xmlns:a16="http://schemas.microsoft.com/office/drawing/2014/main" xmlns="" val="4287365246"/>
                  </a:ext>
                </a:extLst>
              </a:tr>
              <a:tr h="11283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-act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2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2.0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EGFL7B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2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30.0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8.0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0372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extLst>
                  <a:ext uri="{0D108BD9-81ED-4DB2-BD59-A6C34878D82A}">
                    <a16:rowId xmlns:a16="http://schemas.microsoft.com/office/drawing/2014/main" xmlns="" val="1100624043"/>
                  </a:ext>
                </a:extLst>
              </a:tr>
              <a:tr h="11283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-act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2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1.5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EGFL7B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2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30.5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0195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extLst>
                  <a:ext uri="{0D108BD9-81ED-4DB2-BD59-A6C34878D82A}">
                    <a16:rowId xmlns:a16="http://schemas.microsoft.com/office/drawing/2014/main" xmlns="" val="429234343"/>
                  </a:ext>
                </a:extLst>
              </a:tr>
              <a:tr h="11283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-act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2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2.2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EGFL7B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2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9.8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7.6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0504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extLst>
                  <a:ext uri="{0D108BD9-81ED-4DB2-BD59-A6C34878D82A}">
                    <a16:rowId xmlns:a16="http://schemas.microsoft.com/office/drawing/2014/main" xmlns="" val="718334433"/>
                  </a:ext>
                </a:extLst>
              </a:tr>
              <a:tr h="11283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-act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2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1.6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EGFL7B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2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9.8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8.2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0337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0280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.78614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2177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extLst>
                  <a:ext uri="{0D108BD9-81ED-4DB2-BD59-A6C34878D82A}">
                    <a16:rowId xmlns:a16="http://schemas.microsoft.com/office/drawing/2014/main" xmlns="" val="1328786550"/>
                  </a:ext>
                </a:extLst>
              </a:tr>
              <a:tr h="11283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-act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4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2.1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EGFL7B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4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31.2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9.1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0179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0135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1.34804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extLst>
                  <a:ext uri="{0D108BD9-81ED-4DB2-BD59-A6C34878D82A}">
                    <a16:rowId xmlns:a16="http://schemas.microsoft.com/office/drawing/2014/main" xmlns="" val="1900520362"/>
                  </a:ext>
                </a:extLst>
              </a:tr>
              <a:tr h="112836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extLst>
                  <a:ext uri="{0D108BD9-81ED-4DB2-BD59-A6C34878D82A}">
                    <a16:rowId xmlns:a16="http://schemas.microsoft.com/office/drawing/2014/main" xmlns="" val="2844928418"/>
                  </a:ext>
                </a:extLst>
              </a:tr>
              <a:tr h="112836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extLst>
                  <a:ext uri="{0D108BD9-81ED-4DB2-BD59-A6C34878D82A}">
                    <a16:rowId xmlns:a16="http://schemas.microsoft.com/office/drawing/2014/main" xmlns="" val="2092692824"/>
                  </a:ext>
                </a:extLst>
              </a:tr>
              <a:tr h="112836"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extLst>
                  <a:ext uri="{0D108BD9-81ED-4DB2-BD59-A6C34878D82A}">
                    <a16:rowId xmlns:a16="http://schemas.microsoft.com/office/drawing/2014/main" xmlns="" val="1537010155"/>
                  </a:ext>
                </a:extLst>
              </a:tr>
              <a:tr h="11283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-act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C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1.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EGFL7C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C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8.3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6.5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1097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extLst>
                  <a:ext uri="{0D108BD9-81ED-4DB2-BD59-A6C34878D82A}">
                    <a16:rowId xmlns:a16="http://schemas.microsoft.com/office/drawing/2014/main" xmlns="" val="3128149495"/>
                  </a:ext>
                </a:extLst>
              </a:tr>
              <a:tr h="11283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-act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C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0.0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EGFL7C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C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7.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7.8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0442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extLst>
                  <a:ext uri="{0D108BD9-81ED-4DB2-BD59-A6C34878D82A}">
                    <a16:rowId xmlns:a16="http://schemas.microsoft.com/office/drawing/2014/main" xmlns="" val="113748201"/>
                  </a:ext>
                </a:extLst>
              </a:tr>
              <a:tr h="11283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-act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C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0.3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EGFL7C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C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8.1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7.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0448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extLst>
                  <a:ext uri="{0D108BD9-81ED-4DB2-BD59-A6C34878D82A}">
                    <a16:rowId xmlns:a16="http://schemas.microsoft.com/office/drawing/2014/main" xmlns="" val="1080235666"/>
                  </a:ext>
                </a:extLst>
              </a:tr>
              <a:tr h="11283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-act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C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2.0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EGFL7C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C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8.5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6.4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1112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0772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extLst>
                  <a:ext uri="{0D108BD9-81ED-4DB2-BD59-A6C34878D82A}">
                    <a16:rowId xmlns:a16="http://schemas.microsoft.com/office/drawing/2014/main" xmlns="" val="1446821690"/>
                  </a:ext>
                </a:extLst>
              </a:tr>
              <a:tr h="11283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-act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C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1.5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EGFL7C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C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8.62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7.0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0759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0329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42704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extLst>
                  <a:ext uri="{0D108BD9-81ED-4DB2-BD59-A6C34878D82A}">
                    <a16:rowId xmlns:a16="http://schemas.microsoft.com/office/drawing/2014/main" xmlns="" val="2967729120"/>
                  </a:ext>
                </a:extLst>
              </a:tr>
              <a:tr h="11283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-act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1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1.9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EGFL7C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10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7.9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5.9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1584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extLst>
                  <a:ext uri="{0D108BD9-81ED-4DB2-BD59-A6C34878D82A}">
                    <a16:rowId xmlns:a16="http://schemas.microsoft.com/office/drawing/2014/main" xmlns="" val="3994227195"/>
                  </a:ext>
                </a:extLst>
              </a:tr>
              <a:tr h="11283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-act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1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1.5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EGFL7C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1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8.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6.7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0935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extLst>
                  <a:ext uri="{0D108BD9-81ED-4DB2-BD59-A6C34878D82A}">
                    <a16:rowId xmlns:a16="http://schemas.microsoft.com/office/drawing/2014/main" xmlns="" val="1154323806"/>
                  </a:ext>
                </a:extLst>
              </a:tr>
              <a:tr h="11283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-act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2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2.0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EGFL7C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2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7.8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5.8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1733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extLst>
                  <a:ext uri="{0D108BD9-81ED-4DB2-BD59-A6C34878D82A}">
                    <a16:rowId xmlns:a16="http://schemas.microsoft.com/office/drawing/2014/main" xmlns="" val="3728596852"/>
                  </a:ext>
                </a:extLst>
              </a:tr>
              <a:tr h="11283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-act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2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1.5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EGFL7C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2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7.8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6.2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127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extLst>
                  <a:ext uri="{0D108BD9-81ED-4DB2-BD59-A6C34878D82A}">
                    <a16:rowId xmlns:a16="http://schemas.microsoft.com/office/drawing/2014/main" xmlns="" val="4186390460"/>
                  </a:ext>
                </a:extLst>
              </a:tr>
              <a:tr h="11283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-act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2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2.2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EGFL7C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2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5.7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1871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extLst>
                  <a:ext uri="{0D108BD9-81ED-4DB2-BD59-A6C34878D82A}">
                    <a16:rowId xmlns:a16="http://schemas.microsoft.com/office/drawing/2014/main" xmlns="" val="455048803"/>
                  </a:ext>
                </a:extLst>
              </a:tr>
              <a:tr h="11283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-act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2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1.6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EGFL7C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2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7.7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6.0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1509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14245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1.84481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08339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extLst>
                  <a:ext uri="{0D108BD9-81ED-4DB2-BD59-A6C34878D82A}">
                    <a16:rowId xmlns:a16="http://schemas.microsoft.com/office/drawing/2014/main" xmlns="" val="2182804551"/>
                  </a:ext>
                </a:extLst>
              </a:tr>
              <a:tr h="112836"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-actin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4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2.1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EGFL7C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</a:rPr>
                        <a:t>B4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28.6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6.56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10598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00346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600" u="none" strike="noStrike">
                          <a:effectLst/>
                        </a:rPr>
                        <a:t>0.449014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50" marR="5050" marT="5050" marB="0" anchor="b"/>
                </a:tc>
                <a:extLst>
                  <a:ext uri="{0D108BD9-81ED-4DB2-BD59-A6C34878D82A}">
                    <a16:rowId xmlns:a16="http://schemas.microsoft.com/office/drawing/2014/main" xmlns="" val="18687006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78084040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838200" y="685800"/>
            <a:ext cx="825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. 2G</a:t>
            </a:r>
            <a:endParaRPr lang="en-US" dirty="0"/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20336483"/>
              </p:ext>
            </p:extLst>
          </p:nvPr>
        </p:nvGraphicFramePr>
        <p:xfrm>
          <a:off x="3048000" y="2971800"/>
          <a:ext cx="2222499" cy="971550"/>
        </p:xfrm>
        <a:graphic>
          <a:graphicData uri="http://schemas.openxmlformats.org/drawingml/2006/table">
            <a:tbl>
              <a:tblPr/>
              <a:tblGrid>
                <a:gridCol w="740833">
                  <a:extLst>
                    <a:ext uri="{9D8B030D-6E8A-4147-A177-3AD203B41FA5}">
                      <a16:colId xmlns:a16="http://schemas.microsoft.com/office/drawing/2014/main" xmlns="" val="2880801101"/>
                    </a:ext>
                  </a:extLst>
                </a:gridCol>
                <a:gridCol w="740833">
                  <a:extLst>
                    <a:ext uri="{9D8B030D-6E8A-4147-A177-3AD203B41FA5}">
                      <a16:colId xmlns:a16="http://schemas.microsoft.com/office/drawing/2014/main" xmlns="" val="2085985880"/>
                    </a:ext>
                  </a:extLst>
                </a:gridCol>
                <a:gridCol w="740833">
                  <a:extLst>
                    <a:ext uri="{9D8B030D-6E8A-4147-A177-3AD203B41FA5}">
                      <a16:colId xmlns:a16="http://schemas.microsoft.com/office/drawing/2014/main" xmlns="" val="1272893406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.00040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16179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38564148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0.6797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.28171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85294636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5.81942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.25795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63811826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2.11646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42812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8565685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1.3758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42703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04459091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2.95782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.02965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508668678"/>
                  </a:ext>
                </a:extLst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3218334" y="2603108"/>
            <a:ext cx="21579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ean     SD               n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3178814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08236683"/>
              </p:ext>
            </p:extLst>
          </p:nvPr>
        </p:nvGraphicFramePr>
        <p:xfrm>
          <a:off x="1371602" y="3463131"/>
          <a:ext cx="5791199" cy="647700"/>
        </p:xfrm>
        <a:graphic>
          <a:graphicData uri="http://schemas.openxmlformats.org/drawingml/2006/table">
            <a:tbl>
              <a:tblPr/>
              <a:tblGrid>
                <a:gridCol w="832699">
                  <a:extLst>
                    <a:ext uri="{9D8B030D-6E8A-4147-A177-3AD203B41FA5}">
                      <a16:colId xmlns:a16="http://schemas.microsoft.com/office/drawing/2014/main" xmlns="" val="1677132041"/>
                    </a:ext>
                  </a:extLst>
                </a:gridCol>
                <a:gridCol w="795005">
                  <a:extLst>
                    <a:ext uri="{9D8B030D-6E8A-4147-A177-3AD203B41FA5}">
                      <a16:colId xmlns:a16="http://schemas.microsoft.com/office/drawing/2014/main" xmlns="" val="4122369073"/>
                    </a:ext>
                  </a:extLst>
                </a:gridCol>
                <a:gridCol w="832699">
                  <a:extLst>
                    <a:ext uri="{9D8B030D-6E8A-4147-A177-3AD203B41FA5}">
                      <a16:colId xmlns:a16="http://schemas.microsoft.com/office/drawing/2014/main" xmlns="" val="3159867697"/>
                    </a:ext>
                  </a:extLst>
                </a:gridCol>
                <a:gridCol w="832699">
                  <a:extLst>
                    <a:ext uri="{9D8B030D-6E8A-4147-A177-3AD203B41FA5}">
                      <a16:colId xmlns:a16="http://schemas.microsoft.com/office/drawing/2014/main" xmlns="" val="1030690353"/>
                    </a:ext>
                  </a:extLst>
                </a:gridCol>
                <a:gridCol w="832699">
                  <a:extLst>
                    <a:ext uri="{9D8B030D-6E8A-4147-A177-3AD203B41FA5}">
                      <a16:colId xmlns:a16="http://schemas.microsoft.com/office/drawing/2014/main" xmlns="" val="2338217636"/>
                    </a:ext>
                  </a:extLst>
                </a:gridCol>
                <a:gridCol w="832699">
                  <a:extLst>
                    <a:ext uri="{9D8B030D-6E8A-4147-A177-3AD203B41FA5}">
                      <a16:colId xmlns:a16="http://schemas.microsoft.com/office/drawing/2014/main" xmlns="" val="67277335"/>
                    </a:ext>
                  </a:extLst>
                </a:gridCol>
                <a:gridCol w="832699">
                  <a:extLst>
                    <a:ext uri="{9D8B030D-6E8A-4147-A177-3AD203B41FA5}">
                      <a16:colId xmlns:a16="http://schemas.microsoft.com/office/drawing/2014/main" xmlns="" val="309772738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ETS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2.5e-0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0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50546784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ETS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.5e-0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2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7674709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lncEGFL7O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.2e-0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1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13894756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Pri-miR-12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7.4897e-00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36392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16703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122180097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3276600" y="3048000"/>
            <a:ext cx="32679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i-control                         si-ETS1/2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762000" y="762000"/>
            <a:ext cx="8242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. 2H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409315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614</Words>
  <Application>Microsoft Macintosh PowerPoint</Application>
  <PresentationFormat>On-screen Show (4:3)</PresentationFormat>
  <Paragraphs>452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sanna</dc:creator>
  <cp:lastModifiedBy>Susanna</cp:lastModifiedBy>
  <cp:revision>2</cp:revision>
  <dcterms:created xsi:type="dcterms:W3CDTF">2018-12-03T10:45:52Z</dcterms:created>
  <dcterms:modified xsi:type="dcterms:W3CDTF">2018-12-03T10:49:14Z</dcterms:modified>
</cp:coreProperties>
</file>